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57" r:id="rId2"/>
    <p:sldId id="262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585"/>
    <p:restoredTop sz="84422"/>
  </p:normalViewPr>
  <p:slideViewPr>
    <p:cSldViewPr snapToGrid="0" snapToObjects="1">
      <p:cViewPr varScale="1">
        <p:scale>
          <a:sx n="107" d="100"/>
          <a:sy n="107" d="100"/>
        </p:scale>
        <p:origin x="83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6BF332D-31C4-6443-BDF2-1A3182A5B3DF}" type="datetimeFigureOut">
              <a:rPr lang="en-US" smtClean="0"/>
              <a:t>7/15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3FCAA61-6E7D-9C48-B7D2-8F014E72DE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92456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uthor’s own imag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3FCAA61-6E7D-9C48-B7D2-8F014E72DE0D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257148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eilman J. </a:t>
            </a:r>
            <a:r>
              <a:rPr lang="en-US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inus tachycardia as seen on ECG. In: Wikimedia Commons. https://</a:t>
            </a:r>
            <a:r>
              <a:rPr lang="en-US" sz="1200" b="0" i="0" u="none" strike="noStrike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mmons.wikimedia.org</a:t>
            </a:r>
            <a:r>
              <a:rPr lang="en-US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/wiki/</a:t>
            </a:r>
            <a:r>
              <a:rPr lang="en-US" sz="1200" b="0" i="0" u="none" strike="noStrike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le:Sinustachy.JPG</a:t>
            </a:r>
            <a:r>
              <a:rPr lang="en-US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Published Jun 15, 2012. Accessed July 15, 2020. CC BY-SA 3.0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3FCAA61-6E7D-9C48-B7D2-8F014E72DE0D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99251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77450A-0F8A-D942-B8F7-C989E6D94E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E2767E2-AB5C-574A-A379-A9AA7ED4658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429351-AB9E-134D-B246-5B12E2D68F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34706-1782-5E4D-B248-6F2562544B28}" type="datetimeFigureOut">
              <a:rPr lang="en-US" smtClean="0"/>
              <a:t>7/1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4F7948-81F0-E74C-80CA-2C540CBA62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446C9A-9740-C446-BA51-0DA24CC755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33408-B113-9E4E-8F64-A3ADDFBAC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5645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96C6EF-F3F6-2B4F-8AAD-1DF25D0DBC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00EA1BF-5089-0F42-B61B-884DB2D7C1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D513A9-20F0-8E4D-BFA2-23EB434E06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34706-1782-5E4D-B248-6F2562544B28}" type="datetimeFigureOut">
              <a:rPr lang="en-US" smtClean="0"/>
              <a:t>7/1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536B31-35A6-C345-9808-29E88B61EA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85CCD4-3889-1C44-8BED-FB9A266F6C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33408-B113-9E4E-8F64-A3ADDFBAC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31697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C312AD5-147F-7547-B53D-6185190163C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019C00D-0464-B04B-A1F7-A0E3BE3721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9B1BA6-AFD1-8041-8E82-5BAAE5C019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34706-1782-5E4D-B248-6F2562544B28}" type="datetimeFigureOut">
              <a:rPr lang="en-US" smtClean="0"/>
              <a:t>7/1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CD782C-ED2D-4948-A802-898AADE662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3ED006-96C1-7444-954A-44AB2D96FD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33408-B113-9E4E-8F64-A3ADDFBAC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00763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C595E8-BC88-B545-8EC3-BA55E2BB30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527D06-9A52-1240-93FC-AAD98275894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7EE0CD-BB39-6A48-B444-36892F098E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34706-1782-5E4D-B248-6F2562544B28}" type="datetimeFigureOut">
              <a:rPr lang="en-US" smtClean="0"/>
              <a:t>7/1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B0D0FF-5CF5-C54E-B89A-B19F6831F7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BE833C-001A-F245-AE74-BD1D6014DF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33408-B113-9E4E-8F64-A3ADDFBAC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8119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3DF1B3-D2AC-9448-86DF-C1CDC8641C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3526EFB-D878-9143-9C75-905B622A28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D3483A-61C3-F74E-8D4E-DCEEC61D25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34706-1782-5E4D-B248-6F2562544B28}" type="datetimeFigureOut">
              <a:rPr lang="en-US" smtClean="0"/>
              <a:t>7/1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BBB8AB-0915-B14C-9123-FD90A46284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EE1806-A34D-C54D-B7E6-E2A2E17393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33408-B113-9E4E-8F64-A3ADDFBAC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89546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BA97BF-EE2A-034C-84D7-F0B9C406A1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F0348D-8FDA-1E41-B32A-8621EF2D22A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647897-B1E9-EF44-8335-C76CE24E26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2E1C7C-E52D-3F4F-A6FF-EDCF578C63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34706-1782-5E4D-B248-6F2562544B28}" type="datetimeFigureOut">
              <a:rPr lang="en-US" smtClean="0"/>
              <a:t>7/15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456528-E97B-0B47-93E0-9042DFC6B0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ED1834-F601-2A42-AA6B-EAA7921981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33408-B113-9E4E-8F64-A3ADDFBAC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7036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29485B-BF0A-744A-AF2E-70C720F639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833F517-3066-1442-8D8A-E4C1D1C9A5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16D709E-EAD9-5044-8B17-998268BE63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77AED5E-10B2-5D47-A9B8-1954373B955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5979995-F10F-DA4E-BB5D-0DC34CED516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574FE7D-D379-5345-91AD-1D68B4D4A5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34706-1782-5E4D-B248-6F2562544B28}" type="datetimeFigureOut">
              <a:rPr lang="en-US" smtClean="0"/>
              <a:t>7/15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FFAF481-8B4B-2F4D-8274-3105214F67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2D11E1A-31A6-B84A-A26C-A22CAB9006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33408-B113-9E4E-8F64-A3ADDFBAC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304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3EF54D-1FAC-D347-84A4-40CE62FB74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235569D-EC43-4A43-8EBB-97395942DB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34706-1782-5E4D-B248-6F2562544B28}" type="datetimeFigureOut">
              <a:rPr lang="en-US" smtClean="0"/>
              <a:t>7/15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FF47408-835E-ED46-871A-4DC75D39E1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36315EC-11C2-B64B-BF28-56BCCFC83E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33408-B113-9E4E-8F64-A3ADDFBAC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74556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9933E72-E568-0F4E-8A68-EB518F00D6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34706-1782-5E4D-B248-6F2562544B28}" type="datetimeFigureOut">
              <a:rPr lang="en-US" smtClean="0"/>
              <a:t>7/15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0BF296E-7D1C-3646-BF99-BFA8E4EBF0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9FA8A04-2417-4541-899A-B1A0FBA2CF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33408-B113-9E4E-8F64-A3ADDFBAC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02197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BBCB70-906F-B840-9A79-FC3F60267E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9B1F0C-B6AE-5E45-9ACA-E38B9C9516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D2435DA-AD60-954D-860E-16E08E213C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0DEB86-7DA5-E94F-88B6-7A7523F366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34706-1782-5E4D-B248-6F2562544B28}" type="datetimeFigureOut">
              <a:rPr lang="en-US" smtClean="0"/>
              <a:t>7/15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82C859-D0C1-424E-B008-23FFBD413C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1922350-B160-4C4D-977A-74084AD6D4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33408-B113-9E4E-8F64-A3ADDFBAC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5676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0342CA-4CA4-F744-810F-E8567BA012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5A77F6F-2E65-F448-9534-C1E00580EDD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2C8E855-7C83-3C49-9676-A0B741F53D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C67170-C640-814A-98E6-73E91D353E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34706-1782-5E4D-B248-6F2562544B28}" type="datetimeFigureOut">
              <a:rPr lang="en-US" smtClean="0"/>
              <a:t>7/15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B3A72F4-17D7-1449-A97D-A046CAF5A2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DE6FEA-98EC-FC4C-ADFB-3D10AD3498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33408-B113-9E4E-8F64-A3ADDFBAC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4195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3718368-E0EF-6D4E-9945-631E9DB430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7AAD04-6067-EF40-A932-80795C810B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5E8E07-1B49-E444-8FFC-BDB5666B114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C34706-1782-5E4D-B248-6F2562544B28}" type="datetimeFigureOut">
              <a:rPr lang="en-US" smtClean="0"/>
              <a:t>7/1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C7F0E2-8313-9744-B2E0-292DC9F95D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E196C9-3564-5E4D-A580-7C5F734E1D2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133408-B113-9E4E-8F64-A3ADDFBAC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29661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65D752-28E7-BE4C-B172-670853889E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riage Note to enter into Epic Playground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BE45B1-34E2-5044-A997-61449D8B4E0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Patient brought in from SNF with fever, shortness of breath, dry cough, and fever x 1 week and confusion x1 day. O</a:t>
            </a:r>
            <a:r>
              <a:rPr lang="en-US" baseline="-25000" dirty="0"/>
              <a:t>2</a:t>
            </a:r>
            <a:r>
              <a:rPr lang="en-US" dirty="0"/>
              <a:t> </a:t>
            </a:r>
            <a:r>
              <a:rPr lang="en-US" dirty="0" err="1"/>
              <a:t>sats</a:t>
            </a:r>
            <a:r>
              <a:rPr lang="en-US" dirty="0"/>
              <a:t> 67% this morning. Multiple +COVID contacts. </a:t>
            </a:r>
          </a:p>
        </p:txBody>
      </p:sp>
    </p:spTree>
    <p:extLst>
      <p:ext uri="{BB962C8B-B14F-4D97-AF65-F5344CB8AC3E}">
        <p14:creationId xmlns:p14="http://schemas.microsoft.com/office/powerpoint/2010/main" val="5355253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65D752-28E7-BE4C-B172-670853889E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nitial vital signs to enter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BE45B1-34E2-5044-A997-61449D8B4E0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4351338"/>
          </a:xfrm>
        </p:spPr>
        <p:txBody>
          <a:bodyPr numCol="2"/>
          <a:lstStyle/>
          <a:p>
            <a:pPr marL="0" indent="0">
              <a:buNone/>
            </a:pPr>
            <a:r>
              <a:rPr lang="en-US" dirty="0"/>
              <a:t>Heart Rate (HR)	 	122</a:t>
            </a:r>
          </a:p>
          <a:p>
            <a:pPr marL="0" indent="0">
              <a:buNone/>
            </a:pPr>
            <a:r>
              <a:rPr lang="en-US" dirty="0"/>
              <a:t>Blood Pressure (BP)	108/66</a:t>
            </a:r>
          </a:p>
          <a:p>
            <a:pPr marL="0" indent="0">
              <a:buNone/>
            </a:pPr>
            <a:r>
              <a:rPr lang="en-US" dirty="0"/>
              <a:t>Respiratory Rate (RR)	38</a:t>
            </a:r>
          </a:p>
          <a:p>
            <a:pPr marL="0" indent="0">
              <a:buNone/>
            </a:pPr>
            <a:r>
              <a:rPr lang="en-US" dirty="0"/>
              <a:t>O</a:t>
            </a:r>
            <a:r>
              <a:rPr lang="en-US" baseline="-25000" dirty="0"/>
              <a:t>2</a:t>
            </a:r>
            <a:r>
              <a:rPr lang="en-US" dirty="0"/>
              <a:t> Saturation on 6L	79%</a:t>
            </a:r>
          </a:p>
          <a:p>
            <a:pPr marL="0" indent="0">
              <a:buNone/>
            </a:pPr>
            <a:r>
              <a:rPr lang="en-US" dirty="0"/>
              <a:t>Temperature (T)		102.2F				(39</a:t>
            </a:r>
            <a:r>
              <a:rPr lang="en-US" baseline="30000" dirty="0"/>
              <a:t>o</a:t>
            </a:r>
            <a:r>
              <a:rPr lang="en-US" dirty="0"/>
              <a:t>C)				</a:t>
            </a:r>
          </a:p>
        </p:txBody>
      </p:sp>
    </p:spTree>
    <p:extLst>
      <p:ext uri="{BB962C8B-B14F-4D97-AF65-F5344CB8AC3E}">
        <p14:creationId xmlns:p14="http://schemas.microsoft.com/office/powerpoint/2010/main" val="36303407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9BA3BF-233F-D343-A82F-26732BAFBD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ast Medical History	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855E8B0-D337-D649-8E6C-3613E06852E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Hypertension</a:t>
            </a:r>
          </a:p>
          <a:p>
            <a:pPr marL="0" indent="0">
              <a:buNone/>
            </a:pPr>
            <a:r>
              <a:rPr lang="en-US" dirty="0"/>
              <a:t>Diabetes Mellitus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522796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450AE7-F948-6143-B4DE-AA142CB72C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edication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6A47CB8-6C73-A044-B1E9-3F16C4BC4C6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Lisinopril		20 mg daily</a:t>
            </a:r>
          </a:p>
          <a:p>
            <a:pPr marL="0" indent="0">
              <a:buNone/>
            </a:pPr>
            <a:r>
              <a:rPr lang="en-US" dirty="0"/>
              <a:t>Metformin		1000mg twice daily</a:t>
            </a:r>
          </a:p>
          <a:p>
            <a:pPr marL="0" indent="0">
              <a:buNone/>
            </a:pPr>
            <a:r>
              <a:rPr lang="en-US" dirty="0"/>
              <a:t>Enoxaparin 		80mg subcutaneous every 12 hours</a:t>
            </a:r>
          </a:p>
          <a:p>
            <a:pPr marL="0" indent="0">
              <a:buNone/>
            </a:pPr>
            <a:r>
              <a:rPr lang="en-US" dirty="0"/>
              <a:t>Acetaminophen 	500mg every 6 hours as needed		</a:t>
            </a:r>
          </a:p>
        </p:txBody>
      </p:sp>
    </p:spTree>
    <p:extLst>
      <p:ext uri="{BB962C8B-B14F-4D97-AF65-F5344CB8AC3E}">
        <p14:creationId xmlns:p14="http://schemas.microsoft.com/office/powerpoint/2010/main" val="31083662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701C6B-6214-8F46-A422-D473C031AC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err="1"/>
              <a:t>iSTAT</a:t>
            </a:r>
            <a:r>
              <a:rPr lang="en-US" dirty="0"/>
              <a:t> machine showing initial VBG</a:t>
            </a:r>
          </a:p>
        </p:txBody>
      </p:sp>
      <p:pic>
        <p:nvPicPr>
          <p:cNvPr id="5" name="image6.png" descr="A picture containing table, sitting, blue, white&#10;&#10;Description automatically generated">
            <a:extLst>
              <a:ext uri="{FF2B5EF4-FFF2-40B4-BE49-F238E27FC236}">
                <a16:creationId xmlns:a16="http://schemas.microsoft.com/office/drawing/2014/main" id="{5B490458-686C-9940-AF1E-E60A23077EFD}"/>
              </a:ext>
            </a:extLst>
          </p:cNvPr>
          <p:cNvPicPr/>
          <p:nvPr/>
        </p:nvPicPr>
        <p:blipFill>
          <a:blip r:embed="rId3"/>
          <a:srcRect/>
          <a:stretch>
            <a:fillRect/>
          </a:stretch>
        </p:blipFill>
        <p:spPr>
          <a:xfrm>
            <a:off x="4356642" y="1857004"/>
            <a:ext cx="3478716" cy="4635871"/>
          </a:xfrm>
          <a:prstGeom prst="rect">
            <a:avLst/>
          </a:prstGeom>
          <a:ln/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CB2D4F5-2F4A-0640-BC0D-DEE3A5BC0C3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3088359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4F5502-1204-9249-9337-8EAC54A4DC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KG demonstrating sinus tachycardia</a:t>
            </a:r>
          </a:p>
        </p:txBody>
      </p:sp>
      <p:pic>
        <p:nvPicPr>
          <p:cNvPr id="5" name="Picture 4" descr="A large building in the background&#10;&#10;Description automatically generated">
            <a:extLst>
              <a:ext uri="{FF2B5EF4-FFF2-40B4-BE49-F238E27FC236}">
                <a16:creationId xmlns:a16="http://schemas.microsoft.com/office/drawing/2014/main" id="{07D5F884-BD29-9C45-A5E2-175232F62F5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22218" y="1460360"/>
            <a:ext cx="9947564" cy="50325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848971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</TotalTime>
  <Words>196</Words>
  <Application>Microsoft Macintosh PowerPoint</Application>
  <PresentationFormat>Widescreen</PresentationFormat>
  <Paragraphs>22</Paragraphs>
  <Slides>6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Triage Note to enter into Epic Playground</vt:lpstr>
      <vt:lpstr>Initial vital signs to enter</vt:lpstr>
      <vt:lpstr>Past Medical History </vt:lpstr>
      <vt:lpstr>Medications</vt:lpstr>
      <vt:lpstr>iSTAT machine showing initial VBG</vt:lpstr>
      <vt:lpstr>EKG demonstrating sinus tachycardia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ow, Cheyenne</dc:creator>
  <cp:lastModifiedBy>Toohey, Shannon</cp:lastModifiedBy>
  <cp:revision>18</cp:revision>
  <dcterms:created xsi:type="dcterms:W3CDTF">2020-06-29T16:53:05Z</dcterms:created>
  <dcterms:modified xsi:type="dcterms:W3CDTF">2020-07-15T16:26:28Z</dcterms:modified>
</cp:coreProperties>
</file>